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7" r:id="rId2"/>
    <p:sldId id="355" r:id="rId3"/>
    <p:sldId id="358" r:id="rId4"/>
    <p:sldId id="377" r:id="rId5"/>
    <p:sldId id="359" r:id="rId6"/>
    <p:sldId id="379" r:id="rId7"/>
    <p:sldId id="378" r:id="rId8"/>
    <p:sldId id="348" r:id="rId9"/>
    <p:sldId id="375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510" y="108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C9134A-3BB2-93DD-B844-71E0DF5D52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16D5539-1B03-FF9F-F261-79AB690CF1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71CA201-E190-799C-5920-513621DCDE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F9E54-A7B4-4428-B29E-5945B3AA5F19}" type="datetimeFigureOut">
              <a:rPr lang="zh-CN" altLang="en-US" smtClean="0"/>
              <a:t>2023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EE49D5C-1B8C-05C0-5DD8-52415B47E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2D305B-7E49-6FFD-EB63-AC3668DFF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EBF38-72D4-4BAA-833D-0DDB3F3BD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3737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FCF0D8-6672-78D9-D35D-140AC29513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936EC8F-3E78-EB95-2B52-AE2DE63936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40A4080-09A6-8DEE-4077-B3238CDFB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F9E54-A7B4-4428-B29E-5945B3AA5F19}" type="datetimeFigureOut">
              <a:rPr lang="zh-CN" altLang="en-US" smtClean="0"/>
              <a:t>2023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AFEDBF6-9E18-1FCE-6565-F2F9512822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6DB111E-5AA8-B5AB-5F96-9C3B12406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EBF38-72D4-4BAA-833D-0DDB3F3BD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13833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1C6EC9E-55E6-AED2-7939-550506673D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4FD6014-8059-A584-B8D2-9C1B77D402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67A8E92-C45B-830C-1263-186F801EE4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F9E54-A7B4-4428-B29E-5945B3AA5F19}" type="datetimeFigureOut">
              <a:rPr lang="zh-CN" altLang="en-US" smtClean="0"/>
              <a:t>2023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C0FE7A-A308-2C1F-6B83-4038E2B34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75AB68-C521-4192-CD29-7A7F15D92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EBF38-72D4-4BAA-833D-0DDB3F3BD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52663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71C7A8-115B-3B5C-C57A-ED0921BA5C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C58659D-1315-1EA4-0B40-4330C7EFDF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BEA206-EA50-2E7E-6B87-DB2D765A11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F9E54-A7B4-4428-B29E-5945B3AA5F19}" type="datetimeFigureOut">
              <a:rPr lang="zh-CN" altLang="en-US" smtClean="0"/>
              <a:t>2023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560F8E7-2870-6BCE-BBAA-70B7EB989B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BB2B1F9-B2B0-ADDC-2E9C-AF27FD22D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EBF38-72D4-4BAA-833D-0DDB3F3BD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1538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F64CEA-9E48-CD7E-CADA-03AD5F3E5E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F0F0C9B-FE2B-4DA9-AC8A-D72E0782CF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803276A-46D7-54AA-67E7-3B140518A8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F9E54-A7B4-4428-B29E-5945B3AA5F19}" type="datetimeFigureOut">
              <a:rPr lang="zh-CN" altLang="en-US" smtClean="0"/>
              <a:t>2023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3892F30-FAF3-8057-F468-C15359CFE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B6920E9-3302-39B9-B42A-00DE4AC8C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EBF38-72D4-4BAA-833D-0DDB3F3BD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8593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2704FB3-D525-9BF2-DD45-5728E9550F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CCC7AB6-A0E0-C7AA-A55E-A51F659F79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4E64104-2022-6B28-C575-12B60DFB95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E9AA0DA-FA70-B125-15F8-A57CB1B6C7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F9E54-A7B4-4428-B29E-5945B3AA5F19}" type="datetimeFigureOut">
              <a:rPr lang="zh-CN" altLang="en-US" smtClean="0"/>
              <a:t>2023/3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32D6EFF-CCA9-E8B4-A979-96BF74535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25B2B41-AC30-4EAC-17AA-C172AA5E32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EBF38-72D4-4BAA-833D-0DDB3F3BD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14698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950D9E1-EEE3-7C68-B091-849A5A2539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8B79E6B-A9C2-8675-9A24-BB6179D9AD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62BD351-D2D2-127E-AFAB-13AEA353A5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467D66B-A9B8-71AD-5D34-1E2BD7CC8B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0321160-476F-AC70-731C-3637407EB0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F4F0032-6A8A-F7D6-DA5A-313CB40F7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F9E54-A7B4-4428-B29E-5945B3AA5F19}" type="datetimeFigureOut">
              <a:rPr lang="zh-CN" altLang="en-US" smtClean="0"/>
              <a:t>2023/3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34343D7-D2B2-E9EF-BA4D-0E1F6F2178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EEC8741-8F7C-69E8-0049-2E83A78149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EBF38-72D4-4BAA-833D-0DDB3F3BD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1789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86327D-70F8-5510-5CCC-B1F1B69BC9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8796AAE-A3C5-2B4A-36A9-24CE35F487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F9E54-A7B4-4428-B29E-5945B3AA5F19}" type="datetimeFigureOut">
              <a:rPr lang="zh-CN" altLang="en-US" smtClean="0"/>
              <a:t>2023/3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46FA4E0-65BF-7B56-B4C7-8B475F80DE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9241B29-9714-2806-B911-B5D5D42E40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EBF38-72D4-4BAA-833D-0DDB3F3BD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124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8E19DB1-F012-C6D3-8E2C-015FBC1E8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F9E54-A7B4-4428-B29E-5945B3AA5F19}" type="datetimeFigureOut">
              <a:rPr lang="zh-CN" altLang="en-US" smtClean="0"/>
              <a:t>2023/3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93AA3F2-339B-1B31-9F49-EAA7ED9D6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60BC11F-23C2-B923-09B6-263F9A7EAF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EBF38-72D4-4BAA-833D-0DDB3F3BD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0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0FE5528-D084-9D0B-D827-CC001A9415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C08D860-1B92-75CA-D18C-D1E74FE996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E166D39-A94C-1CCC-889B-ACBC394B22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A43E25D-5431-89BE-DB4A-D5A74F53F0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F9E54-A7B4-4428-B29E-5945B3AA5F19}" type="datetimeFigureOut">
              <a:rPr lang="zh-CN" altLang="en-US" smtClean="0"/>
              <a:t>2023/3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135C372-F67D-5F64-2B31-A10887403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B513DB5-FE71-D709-6BC3-D92534633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EBF38-72D4-4BAA-833D-0DDB3F3BD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6308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36DEA7-DC12-4A1D-1CDD-7291912B7A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7ADB786-9376-216A-19B8-8DC4AF3811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B1D8652-820B-B098-F335-202E73CBAA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A7FAFA1-F104-378A-567A-4C04C50B62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F9E54-A7B4-4428-B29E-5945B3AA5F19}" type="datetimeFigureOut">
              <a:rPr lang="zh-CN" altLang="en-US" smtClean="0"/>
              <a:t>2023/3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E03CA7E-A22F-670D-265D-149DF89103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ED21C25-7E5C-1941-82BA-F62E0430C9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EBF38-72D4-4BAA-833D-0DDB3F3BD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4623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342E149-B5AF-395C-B663-5E61AC839E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ECA1F2-A7DF-89F2-7BD2-8E4702B200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94B40BA-4E3E-9C21-49E9-1F85942C67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EF9E54-A7B4-4428-B29E-5945B3AA5F19}" type="datetimeFigureOut">
              <a:rPr lang="zh-CN" altLang="en-US" smtClean="0"/>
              <a:t>2023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43C58B2-3CAC-EB35-23AF-8EA9AD4E6D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B9FA55C-C882-6737-F34E-80A9EBCFD8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7EBF38-72D4-4BAA-833D-0DDB3F3BDB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9638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868C34B-1A1D-ADD4-1004-13EE5892A923}"/>
              </a:ext>
            </a:extLst>
          </p:cNvPr>
          <p:cNvSpPr txBox="1"/>
          <p:nvPr/>
        </p:nvSpPr>
        <p:spPr>
          <a:xfrm>
            <a:off x="219634" y="154400"/>
            <a:ext cx="10134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Fig S1</a:t>
            </a:r>
            <a:endParaRPr lang="zh-CN" altLang="en-US" sz="2400" b="1" kern="1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89EC0E0F-F789-2287-071C-EAAAD7F7C5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3553" y="0"/>
            <a:ext cx="686489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41845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CE9CB84-75AD-8B2E-338A-7C2F727415A0}"/>
              </a:ext>
            </a:extLst>
          </p:cNvPr>
          <p:cNvSpPr txBox="1"/>
          <p:nvPr/>
        </p:nvSpPr>
        <p:spPr>
          <a:xfrm>
            <a:off x="219634" y="154400"/>
            <a:ext cx="10134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Fig S2</a:t>
            </a:r>
            <a:endParaRPr lang="zh-CN" altLang="en-US" sz="2400" b="1" kern="1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E28B1D5-7A51-7EDE-6DC2-EF0270D1D9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4587" y="254915"/>
            <a:ext cx="5706904" cy="63481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57804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8EB3FBD6-EF03-002E-4006-3C8CD318B17A}"/>
              </a:ext>
            </a:extLst>
          </p:cNvPr>
          <p:cNvSpPr txBox="1"/>
          <p:nvPr/>
        </p:nvSpPr>
        <p:spPr>
          <a:xfrm>
            <a:off x="219634" y="154400"/>
            <a:ext cx="10134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Fig S3</a:t>
            </a:r>
            <a:endParaRPr lang="zh-CN" altLang="en-US" sz="2400" b="1" kern="1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8254F43C-B6C3-2752-8B06-BF740432D1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4272" y="710184"/>
            <a:ext cx="9363456" cy="54376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80432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A602ABA-6663-01C4-AE90-0E95C089EE3F}"/>
              </a:ext>
            </a:extLst>
          </p:cNvPr>
          <p:cNvSpPr txBox="1"/>
          <p:nvPr/>
        </p:nvSpPr>
        <p:spPr>
          <a:xfrm>
            <a:off x="219634" y="154400"/>
            <a:ext cx="10134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Fig S4</a:t>
            </a:r>
            <a:endParaRPr lang="zh-CN" altLang="en-US" sz="2400" b="1" kern="1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8E5B769E-AB98-E42E-9537-2A2146A9E6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0328" y="1357122"/>
            <a:ext cx="9991344" cy="41437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61297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0532E6E-ECE8-0AE4-CBA8-6FC225E3DE76}"/>
              </a:ext>
            </a:extLst>
          </p:cNvPr>
          <p:cNvSpPr txBox="1"/>
          <p:nvPr/>
        </p:nvSpPr>
        <p:spPr>
          <a:xfrm>
            <a:off x="219634" y="154400"/>
            <a:ext cx="10134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Fig S5</a:t>
            </a:r>
            <a:endParaRPr lang="zh-CN" altLang="en-US" sz="2400" b="1" kern="1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8D474DE5-DF2C-BF24-F215-A15DEDBBC0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7377" y="0"/>
            <a:ext cx="753724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83976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273AC179-97D7-18E4-24B3-2E80ECFB8E42}"/>
              </a:ext>
            </a:extLst>
          </p:cNvPr>
          <p:cNvSpPr txBox="1"/>
          <p:nvPr/>
        </p:nvSpPr>
        <p:spPr>
          <a:xfrm>
            <a:off x="219634" y="154400"/>
            <a:ext cx="10134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Fig S6</a:t>
            </a:r>
            <a:endParaRPr lang="zh-CN" altLang="en-US" sz="2400" b="1" kern="1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7899AE9-0F39-BB2D-AE0D-6B9E1D5A7C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0516" y="0"/>
            <a:ext cx="343096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56747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12078C9-19EC-7B16-8A0B-7C0B468F2C0A}"/>
              </a:ext>
            </a:extLst>
          </p:cNvPr>
          <p:cNvSpPr txBox="1"/>
          <p:nvPr/>
        </p:nvSpPr>
        <p:spPr>
          <a:xfrm>
            <a:off x="219634" y="154400"/>
            <a:ext cx="10134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Fig S7</a:t>
            </a:r>
            <a:endParaRPr lang="zh-CN" altLang="en-US" sz="2400" b="1" kern="1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6FA46CC-5ECD-EDEB-56A0-6DB5C876F8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9546" y="793242"/>
            <a:ext cx="10974006" cy="57802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52079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C9CEA8B-58ED-B22C-76D0-3FF601C5D9FE}"/>
              </a:ext>
            </a:extLst>
          </p:cNvPr>
          <p:cNvSpPr txBox="1"/>
          <p:nvPr/>
        </p:nvSpPr>
        <p:spPr>
          <a:xfrm>
            <a:off x="219634" y="154400"/>
            <a:ext cx="10134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Fig S8</a:t>
            </a:r>
            <a:endParaRPr lang="zh-CN" altLang="en-US" sz="2400" b="1" kern="1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EE5E8CA-7C22-A7EA-4DD6-22FFE5F9C1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1298" y="100584"/>
            <a:ext cx="9709404" cy="66568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972595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943992E-9083-CFB1-9670-26550C924F52}"/>
              </a:ext>
            </a:extLst>
          </p:cNvPr>
          <p:cNvSpPr txBox="1"/>
          <p:nvPr/>
        </p:nvSpPr>
        <p:spPr>
          <a:xfrm>
            <a:off x="219634" y="154400"/>
            <a:ext cx="10134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Fig S9</a:t>
            </a:r>
            <a:endParaRPr lang="zh-CN" altLang="en-US" sz="2400" b="1" kern="1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5C3B9C2-DFB1-2F01-1305-7A4E742AAC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0176" y="32004"/>
            <a:ext cx="7851648" cy="67939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66564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12</TotalTime>
  <Words>18</Words>
  <Application>Microsoft Office PowerPoint</Application>
  <PresentationFormat>宽屏</PresentationFormat>
  <Paragraphs>9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4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oge</dc:creator>
  <cp:lastModifiedBy>温 天洋</cp:lastModifiedBy>
  <cp:revision>32</cp:revision>
  <dcterms:created xsi:type="dcterms:W3CDTF">2022-11-16T08:47:36Z</dcterms:created>
  <dcterms:modified xsi:type="dcterms:W3CDTF">2023-03-18T09:25:19Z</dcterms:modified>
</cp:coreProperties>
</file>